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160FE1-143C-4BDA-B468-C70E632858B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927518-DE1B-4D42-8B6A-6804EB26231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2D0E23-150E-479E-B949-10F05565ED6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E6E593-F860-4D16-B760-16F54A224FC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7791D5-8BFF-4B0F-A2FF-B9E211365EE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E182EB-EAE8-46BB-B11D-20FE18F6ABD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5284D0-C494-49C1-A8A9-AC7D6CDE496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E5AEE5-AFAD-4946-9786-5E29FFD3F37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E08105-9929-4B6D-AA2C-5E081646D63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8BF5A6-B08C-424F-A831-E3F1EC9363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21DC0D-3CE2-46B0-88D9-E3443F57686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4B7169-C0CA-4C3B-89A6-962325717D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7D68407-6E14-4E58-9B74-EEF3754E757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10771" t="5772" r="13694" b="6940"/>
          <a:stretch/>
        </p:blipFill>
        <p:spPr>
          <a:xfrm>
            <a:off x="5121360" y="0"/>
            <a:ext cx="4022640" cy="400356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rcRect l="11962" t="4276" r="6217" b="9351"/>
          <a:stretch/>
        </p:blipFill>
        <p:spPr>
          <a:xfrm>
            <a:off x="250920" y="44280"/>
            <a:ext cx="3967200" cy="381636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>
            <a:off x="962280" y="2882880"/>
            <a:ext cx="47160" cy="185040"/>
          </a:xfrm>
          <a:custGeom>
            <a:avLst/>
            <a:gdLst>
              <a:gd name="textAreaLeft" fmla="*/ 360 w 47160"/>
              <a:gd name="textAreaRight" fmla="*/ 46800 w 47160"/>
              <a:gd name="textAreaTop" fmla="*/ 360 h 185040"/>
              <a:gd name="textAreaBottom" fmla="*/ 184680 h 185040"/>
            </a:gdLst>
            <a:ahLst/>
            <a:rect l="textAreaLeft" t="textAreaTop" r="textAreaRight" b="textAreaBottom"/>
            <a:pathLst>
              <a:path w="21600" h="84273">
                <a:moveTo>
                  <a:pt x="720" y="0"/>
                </a:moveTo>
                <a:arcTo wR="720" hR="720" stAng="16200000" swAng="-5400000"/>
                <a:lnTo>
                  <a:pt x="0" y="83553"/>
                </a:lnTo>
                <a:arcTo wR="720" hR="720" stAng="10800000" swAng="-5400000"/>
                <a:lnTo>
                  <a:pt x="20880" y="84273"/>
                </a:lnTo>
                <a:arcTo wR="720" hR="720" stAng="5400000" swAng="-5400000"/>
                <a:lnTo>
                  <a:pt x="21600" y="720"/>
                </a:lnTo>
                <a:arcTo wR="720" hR="720" stAng="0" swAng="-5400000"/>
                <a:close/>
              </a:path>
            </a:pathLst>
          </a:cu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06440"/>
                <a:tab algn="l" pos="814320"/>
                <a:tab algn="l" pos="1220760"/>
                <a:tab algn="l" pos="1628640"/>
                <a:tab algn="l" pos="2036880"/>
                <a:tab algn="l" pos="2443320"/>
                <a:tab algn="l" pos="2851200"/>
                <a:tab algn="l" pos="3259080"/>
                <a:tab algn="l" pos="3665520"/>
                <a:tab algn="l" pos="4073400"/>
                <a:tab algn="l" pos="4481640"/>
                <a:tab algn="l" pos="4889520"/>
                <a:tab algn="l" pos="5295960"/>
                <a:tab algn="l" pos="5703840"/>
                <a:tab algn="l" pos="6111720"/>
                <a:tab algn="l" pos="6518160"/>
                <a:tab algn="l" pos="6926400"/>
                <a:tab algn="l" pos="7334280"/>
                <a:tab algn="l" pos="7742160"/>
                <a:tab algn="l" pos="8148600"/>
                <a:tab algn="l" pos="8286840"/>
                <a:tab algn="l" pos="9115560"/>
                <a:tab algn="l" pos="9944280"/>
                <a:tab algn="l" pos="10772640"/>
              </a:tabLst>
            </a:pPr>
            <a:r>
              <a:rPr b="1" lang="en-GB" sz="13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" descr=""/>
          <p:cNvPicPr/>
          <p:nvPr/>
        </p:nvPicPr>
        <p:blipFill>
          <a:blip r:embed="rId3"/>
          <a:srcRect l="20292" t="24929" r="30687" b="24278"/>
          <a:stretch/>
        </p:blipFill>
        <p:spPr>
          <a:xfrm>
            <a:off x="3059280" y="4149720"/>
            <a:ext cx="2879640" cy="2398680"/>
          </a:xfrm>
          <a:prstGeom prst="rect">
            <a:avLst/>
          </a:prstGeom>
          <a:ln w="0">
            <a:noFill/>
          </a:ln>
        </p:spPr>
      </p:pic>
      <p:sp>
        <p:nvSpPr>
          <p:cNvPr id="45" name=""/>
          <p:cNvSpPr/>
          <p:nvPr/>
        </p:nvSpPr>
        <p:spPr>
          <a:xfrm>
            <a:off x="2568600" y="6373800"/>
            <a:ext cx="4164120" cy="367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B0954: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hydroxydecanoyl-[acyl-carrier-protein] dehydratas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3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(Fatty acid metabolism; Biosynthesis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79280" y="3789360"/>
            <a:ext cx="3888000" cy="353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06440"/>
                <a:tab algn="l" pos="814320"/>
                <a:tab algn="l" pos="1220760"/>
                <a:tab algn="l" pos="1628640"/>
                <a:tab algn="l" pos="2036880"/>
                <a:tab algn="l" pos="2443320"/>
                <a:tab algn="l" pos="2851200"/>
                <a:tab algn="l" pos="3259080"/>
                <a:tab algn="l" pos="3665520"/>
                <a:tab algn="l" pos="4073400"/>
                <a:tab algn="l" pos="4481640"/>
                <a:tab algn="l" pos="4889520"/>
                <a:tab algn="l" pos="5295960"/>
                <a:tab algn="l" pos="5703840"/>
                <a:tab algn="l" pos="6111720"/>
                <a:tab algn="l" pos="6518160"/>
                <a:tab algn="l" pos="6926400"/>
                <a:tab algn="l" pos="7334280"/>
                <a:tab algn="l" pos="7742160"/>
                <a:tab algn="l" pos="8148600"/>
                <a:tab algn="l" pos="8286840"/>
                <a:tab algn="l" pos="9115560"/>
                <a:tab algn="l" pos="9944280"/>
                <a:tab algn="l" pos="10772640"/>
              </a:tabLst>
            </a:pPr>
            <a:r>
              <a:rPr b="1" lang="en-GB" sz="1300" spc="-1" strike="noStrike">
                <a:solidFill>
                  <a:srgbClr val="000000"/>
                </a:solidFill>
                <a:latin typeface="Arial"/>
              </a:rPr>
              <a:t>B1215: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2-dehydro-3-deoxyphosphooctonate aldolas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3000"/>
              </a:lnSpc>
              <a:tabLst>
                <a:tab algn="l" pos="0"/>
                <a:tab algn="l" pos="406440"/>
                <a:tab algn="l" pos="814320"/>
                <a:tab algn="l" pos="1220760"/>
                <a:tab algn="l" pos="1628640"/>
                <a:tab algn="l" pos="2036880"/>
                <a:tab algn="l" pos="2443320"/>
                <a:tab algn="l" pos="2851200"/>
                <a:tab algn="l" pos="3259080"/>
                <a:tab algn="l" pos="3665520"/>
                <a:tab algn="l" pos="4073400"/>
                <a:tab algn="l" pos="4481640"/>
                <a:tab algn="l" pos="4889520"/>
                <a:tab algn="l" pos="5295960"/>
                <a:tab algn="l" pos="5703840"/>
                <a:tab algn="l" pos="6111720"/>
                <a:tab algn="l" pos="6518160"/>
                <a:tab algn="l" pos="6926400"/>
                <a:tab algn="l" pos="7334280"/>
                <a:tab algn="l" pos="7742160"/>
                <a:tab algn="l" pos="8148600"/>
                <a:tab algn="l" pos="8286840"/>
                <a:tab algn="l" pos="9115560"/>
                <a:tab algn="l" pos="9944280"/>
                <a:tab algn="l" pos="1077264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(Cell envelope; Biosynthesis of surface polysaccharides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5364000" y="3933720"/>
            <a:ext cx="3745080" cy="353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06440"/>
                <a:tab algn="l" pos="814320"/>
                <a:tab algn="l" pos="1220760"/>
                <a:tab algn="l" pos="1628640"/>
                <a:tab algn="l" pos="2036880"/>
                <a:tab algn="l" pos="2443320"/>
                <a:tab algn="l" pos="2851200"/>
                <a:tab algn="l" pos="3259080"/>
                <a:tab algn="l" pos="3665520"/>
                <a:tab algn="l" pos="4073400"/>
                <a:tab algn="l" pos="4481640"/>
                <a:tab algn="l" pos="4889520"/>
                <a:tab algn="l" pos="5295960"/>
                <a:tab algn="l" pos="5703840"/>
                <a:tab algn="l" pos="6111720"/>
                <a:tab algn="l" pos="6518160"/>
                <a:tab algn="l" pos="6926400"/>
                <a:tab algn="l" pos="7334280"/>
                <a:tab algn="l" pos="7742160"/>
                <a:tab algn="l" pos="8148600"/>
                <a:tab algn="l" pos="8286840"/>
                <a:tab algn="l" pos="9115560"/>
                <a:tab algn="l" pos="9944280"/>
                <a:tab algn="l" pos="10772640"/>
              </a:tabLst>
            </a:pPr>
            <a:r>
              <a:rPr b="1" lang="en-GB" sz="1300" spc="-1" strike="noStrike">
                <a:solidFill>
                  <a:srgbClr val="000000"/>
                </a:solidFill>
                <a:latin typeface="Arial"/>
              </a:rPr>
              <a:t>B0660: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PhoH-like prote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3000"/>
              </a:lnSpc>
              <a:tabLst>
                <a:tab algn="l" pos="0"/>
                <a:tab algn="l" pos="406440"/>
                <a:tab algn="l" pos="814320"/>
                <a:tab algn="l" pos="1220760"/>
                <a:tab algn="l" pos="1628640"/>
                <a:tab algn="l" pos="2036880"/>
                <a:tab algn="l" pos="2443320"/>
                <a:tab algn="l" pos="2851200"/>
                <a:tab algn="l" pos="3259080"/>
                <a:tab algn="l" pos="3665520"/>
                <a:tab algn="l" pos="4073400"/>
                <a:tab algn="l" pos="4481640"/>
                <a:tab algn="l" pos="4889520"/>
                <a:tab algn="l" pos="5295960"/>
                <a:tab algn="l" pos="5703840"/>
                <a:tab algn="l" pos="6111720"/>
                <a:tab algn="l" pos="6518160"/>
                <a:tab algn="l" pos="6926400"/>
                <a:tab algn="l" pos="7334280"/>
                <a:tab algn="l" pos="7742160"/>
                <a:tab algn="l" pos="8148600"/>
                <a:tab algn="l" pos="8286840"/>
                <a:tab algn="l" pos="9115560"/>
                <a:tab algn="l" pos="9944280"/>
                <a:tab algn="l" pos="1077264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(Celullar processes; Adaptation to atypical conditions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"/>
          <p:cNvSpPr/>
          <p:nvPr/>
        </p:nvSpPr>
        <p:spPr>
          <a:xfrm>
            <a:off x="324000" y="549360"/>
            <a:ext cx="8280360" cy="146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S2: Three examples of hub deletion in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Buchnera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. The pictures show the area surrounding three highly connected nodes that have been deleted in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Buchnera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. As can be seen, this loss can be tolerated because other highly connected nodes in the vicinity are conserved and maintain the integrity of the network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5-15T13:04:24Z</dcterms:created>
  <dc:creator>Javier</dc:creator>
  <dc:description/>
  <dc:language>en-US</dc:language>
  <cp:lastModifiedBy>Javier</cp:lastModifiedBy>
  <dcterms:modified xsi:type="dcterms:W3CDTF">2007-05-17T10:52:57Z</dcterms:modified>
  <cp:revision>5</cp:revision>
  <dc:subject/>
  <dc:title>Diapositiva 1</dc:title>
</cp:coreProperties>
</file>